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F00"/>
    <a:srgbClr val="C852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381"/>
    <p:restoredTop sz="82160" autoAdjust="0"/>
  </p:normalViewPr>
  <p:slideViewPr>
    <p:cSldViewPr snapToGrid="0" snapToObjects="1">
      <p:cViewPr varScale="1">
        <p:scale>
          <a:sx n="90" d="100"/>
          <a:sy n="90" d="100"/>
        </p:scale>
        <p:origin x="272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9F68CD-90C4-7748-8CEA-A390B91AC6E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FDD35-CC67-FC44-BD99-08DD78BBA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6568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E4DEA8-D882-B641-883F-47F659727EB0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138FEA-BD44-E842-97FF-1F7DD025F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558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138FEA-BD44-E842-97FF-1F7DD025F3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200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1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631076" y="5338256"/>
            <a:ext cx="631727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ediction of fiber length using different numbers of the effect-selected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with nine prediction models. The transcript expressions of the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were used for the prediction. Each number of the selected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consisted of 50% that had the positive effects and smallest negative effects on fiber length and 50% that had the largest negative effect on fiber length. Different colors indicate the different numbers of the effect-selected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used for the prediction of fiber length.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631078" y="281921"/>
            <a:ext cx="5843259" cy="5011864"/>
            <a:chOff x="1631078" y="420868"/>
            <a:chExt cx="5843259" cy="501186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92687" y="420868"/>
              <a:ext cx="5581650" cy="4714875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3947531" y="5171122"/>
              <a:ext cx="19271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selected 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L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s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1021937" y="2558019"/>
              <a:ext cx="14798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diction accuracy (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18635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28</TotalTime>
  <Words>99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cotton GBB manuscript</dc:title>
  <dc:creator>ellyce Liu</dc:creator>
  <cp:lastModifiedBy>Zhang, Hongbin</cp:lastModifiedBy>
  <cp:revision>301</cp:revision>
  <cp:lastPrinted>2017-01-23T15:43:11Z</cp:lastPrinted>
  <dcterms:created xsi:type="dcterms:W3CDTF">2017-01-04T23:35:27Z</dcterms:created>
  <dcterms:modified xsi:type="dcterms:W3CDTF">2020-07-13T17:06:49Z</dcterms:modified>
</cp:coreProperties>
</file>